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26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9FDDF-0A1B-42A8-BFAA-1BFFD6F9330D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C81CCF-59F6-4571-8C98-60FC0CB410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716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http://rice.plantbiology.msu.edu/cgi-bin/ORF_infopage.cgi?orf=LOC_Os03g46490.1" TargetMode="External"/><Relationship Id="rId13" Type="http://schemas.openxmlformats.org/officeDocument/2006/relationships/hyperlink" Target="http://rice.plantbiology.msu.edu/cgi-bin/ORF_infopage.cgi?orf=LOC_Os03g46570.1" TargetMode="External"/><Relationship Id="rId18" Type="http://schemas.openxmlformats.org/officeDocument/2006/relationships/hyperlink" Target="http://rice.plantbiology.msu.edu/cgi-bin/ORF_infopage.cgi?orf=LOC_Os03g46650.1" TargetMode="External"/><Relationship Id="rId26" Type="http://schemas.openxmlformats.org/officeDocument/2006/relationships/hyperlink" Target="http://rice.plantbiology.msu.edu/cgi-bin/ORF_infopage.cgi?orf=LOC_Os03g46800.1" TargetMode="External"/><Relationship Id="rId39" Type="http://schemas.openxmlformats.org/officeDocument/2006/relationships/hyperlink" Target="http://rice.plantbiology.msu.edu/cgi-bin/ORF_infopage.cgi?orf=LOC_Os03g47140.1" TargetMode="External"/><Relationship Id="rId3" Type="http://schemas.openxmlformats.org/officeDocument/2006/relationships/hyperlink" Target="http://rice.plantbiology.msu.edu/cgi-bin/ORF_infopage.cgi?orf=LOC_Os03g46450.1" TargetMode="External"/><Relationship Id="rId21" Type="http://schemas.openxmlformats.org/officeDocument/2006/relationships/hyperlink" Target="http://rice.plantbiology.msu.edu/cgi-bin/ORF_infopage.cgi?orf=LOC_Os03g46690.1" TargetMode="External"/><Relationship Id="rId34" Type="http://schemas.openxmlformats.org/officeDocument/2006/relationships/hyperlink" Target="http://rice.plantbiology.msu.edu/cgi-bin/ORF_infopage.cgi?orf=LOC_Os03g47022.1" TargetMode="External"/><Relationship Id="rId42" Type="http://schemas.openxmlformats.org/officeDocument/2006/relationships/hyperlink" Target="http://rice.plantbiology.msu.edu/cgi-bin/ORF_infopage.cgi?orf=LOC_Os03g47230.1" TargetMode="External"/><Relationship Id="rId7" Type="http://schemas.openxmlformats.org/officeDocument/2006/relationships/hyperlink" Target="http://rice.plantbiology.msu.edu/cgi-bin/ORF_infopage.cgi?orf=LOC_Os03g46480.1" TargetMode="External"/><Relationship Id="rId12" Type="http://schemas.openxmlformats.org/officeDocument/2006/relationships/hyperlink" Target="http://rice.plantbiology.msu.edu/cgi-bin/ORF_infopage.cgi?orf=LOC_Os03g46560.1" TargetMode="External"/><Relationship Id="rId17" Type="http://schemas.openxmlformats.org/officeDocument/2006/relationships/hyperlink" Target="http://rice.plantbiology.msu.edu/cgi-bin/ORF_infopage.cgi?orf=LOC_Os03g46640.1" TargetMode="External"/><Relationship Id="rId25" Type="http://schemas.openxmlformats.org/officeDocument/2006/relationships/hyperlink" Target="http://rice.plantbiology.msu.edu/cgi-bin/ORF_infopage.cgi?orf=LOC_Os03g46790.1" TargetMode="External"/><Relationship Id="rId33" Type="http://schemas.openxmlformats.org/officeDocument/2006/relationships/hyperlink" Target="http://rice.plantbiology.msu.edu/cgi-bin/ORF_infopage.cgi?orf=LOC_Os03g47016.1" TargetMode="External"/><Relationship Id="rId38" Type="http://schemas.openxmlformats.org/officeDocument/2006/relationships/hyperlink" Target="http://rice.plantbiology.msu.edu/cgi-bin/ORF_infopage.cgi?orf=LOC_Os03g47130.1" TargetMode="External"/><Relationship Id="rId2" Type="http://schemas.openxmlformats.org/officeDocument/2006/relationships/hyperlink" Target="http://rice.plantbiology.msu.edu/cgi-bin/ORF_infopage.cgi?orf=LOC_Os03g46440.1" TargetMode="External"/><Relationship Id="rId16" Type="http://schemas.openxmlformats.org/officeDocument/2006/relationships/hyperlink" Target="http://rice.plantbiology.msu.edu/cgi-bin/ORF_infopage.cgi?orf=LOC_Os03g46610.1" TargetMode="External"/><Relationship Id="rId20" Type="http://schemas.openxmlformats.org/officeDocument/2006/relationships/hyperlink" Target="http://rice.plantbiology.msu.edu/cgi-bin/ORF_infopage.cgi?orf=LOC_Os03g46674.1" TargetMode="External"/><Relationship Id="rId29" Type="http://schemas.openxmlformats.org/officeDocument/2006/relationships/hyperlink" Target="http://rice.plantbiology.msu.edu/cgi-bin/ORF_infopage.cgi?orf=LOC_Os03g46910.1" TargetMode="External"/><Relationship Id="rId41" Type="http://schemas.openxmlformats.org/officeDocument/2006/relationships/hyperlink" Target="http://rice.plantbiology.msu.edu/cgi-bin/ORF_infopage.cgi?orf=LOC_Os03g47200.1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://rice.plantbiology.msu.edu/cgi-bin/ORF_infopage.cgi?orf=LOC_Os03g46470.1" TargetMode="External"/><Relationship Id="rId11" Type="http://schemas.openxmlformats.org/officeDocument/2006/relationships/hyperlink" Target="http://rice.plantbiology.msu.edu/cgi-bin/ORF_infopage.cgi?orf=LOC_Os03g46550.1" TargetMode="External"/><Relationship Id="rId24" Type="http://schemas.openxmlformats.org/officeDocument/2006/relationships/hyperlink" Target="http://rice.plantbiology.msu.edu/cgi-bin/ORF_infopage.cgi?orf=LOC_Os03g46750.1" TargetMode="External"/><Relationship Id="rId32" Type="http://schemas.openxmlformats.org/officeDocument/2006/relationships/hyperlink" Target="http://rice.plantbiology.msu.edu/cgi-bin/ORF_infopage.cgi?orf=LOC_Os03g47000.1" TargetMode="External"/><Relationship Id="rId37" Type="http://schemas.openxmlformats.org/officeDocument/2006/relationships/hyperlink" Target="http://rice.plantbiology.msu.edu/cgi-bin/ORF_infopage.cgi?orf=LOC_Os03g47120.1" TargetMode="External"/><Relationship Id="rId40" Type="http://schemas.openxmlformats.org/officeDocument/2006/relationships/hyperlink" Target="http://rice.plantbiology.msu.edu/cgi-bin/ORF_infopage.cgi?orf=LOC_Os03g47169.1" TargetMode="External"/><Relationship Id="rId5" Type="http://schemas.openxmlformats.org/officeDocument/2006/relationships/hyperlink" Target="http://rice.plantbiology.msu.edu/cgi-bin/ORF_infopage.cgi?orf=LOC_Os03g46460.1" TargetMode="External"/><Relationship Id="rId15" Type="http://schemas.openxmlformats.org/officeDocument/2006/relationships/hyperlink" Target="http://rice.plantbiology.msu.edu/cgi-bin/ORF_infopage.cgi?orf=LOC_Os03g46600.1" TargetMode="External"/><Relationship Id="rId23" Type="http://schemas.openxmlformats.org/officeDocument/2006/relationships/hyperlink" Target="http://rice.plantbiology.msu.edu/cgi-bin/ORF_infopage.cgi?orf=LOC_Os03g46740.1" TargetMode="External"/><Relationship Id="rId28" Type="http://schemas.openxmlformats.org/officeDocument/2006/relationships/hyperlink" Target="http://rice.plantbiology.msu.edu/cgi-bin/ORF_infopage.cgi?orf=LOC_Os03g46884.1" TargetMode="External"/><Relationship Id="rId36" Type="http://schemas.openxmlformats.org/officeDocument/2006/relationships/hyperlink" Target="http://rice.plantbiology.msu.edu/cgi-bin/ORF_infopage.cgi?orf=LOC_Os03g47100.1" TargetMode="External"/><Relationship Id="rId10" Type="http://schemas.openxmlformats.org/officeDocument/2006/relationships/hyperlink" Target="http://rice.plantbiology.msu.edu/cgi-bin/ORF_infopage.cgi?orf=LOC_Os03g46500.1" TargetMode="External"/><Relationship Id="rId19" Type="http://schemas.openxmlformats.org/officeDocument/2006/relationships/hyperlink" Target="http://rice.plantbiology.msu.edu/cgi-bin/ORF_infopage.cgi?orf=LOC_Os03g46660.1" TargetMode="External"/><Relationship Id="rId31" Type="http://schemas.openxmlformats.org/officeDocument/2006/relationships/hyperlink" Target="http://rice.plantbiology.msu.edu/cgi-bin/ORF_infopage.cgi?orf=LOC_Os03g46970.1" TargetMode="External"/><Relationship Id="rId4" Type="http://schemas.openxmlformats.org/officeDocument/2006/relationships/hyperlink" Target="http://rice.plantbiology.msu.edu/cgi-bin/ORF_infopage.cgi?orf=LOC_Os03g46454.1" TargetMode="External"/><Relationship Id="rId9" Type="http://schemas.openxmlformats.org/officeDocument/2006/relationships/hyperlink" Target="http://rice.plantbiology.msu.edu/cgi-bin/ORF_infopage.cgi?orf=LOC_Os03g46510.1" TargetMode="External"/><Relationship Id="rId14" Type="http://schemas.openxmlformats.org/officeDocument/2006/relationships/hyperlink" Target="http://rice.plantbiology.msu.edu/cgi-bin/ORF_infopage.cgi?orf=LOC_Os03g46590.1" TargetMode="External"/><Relationship Id="rId22" Type="http://schemas.openxmlformats.org/officeDocument/2006/relationships/hyperlink" Target="http://rice.plantbiology.msu.edu/cgi-bin/ORF_infopage.cgi?orf=LOC_Os03g46720.1" TargetMode="External"/><Relationship Id="rId27" Type="http://schemas.openxmlformats.org/officeDocument/2006/relationships/hyperlink" Target="http://rice.plantbiology.msu.edu/cgi-bin/ORF_infopage.cgi?orf=LOC_Os03g46830.1" TargetMode="External"/><Relationship Id="rId30" Type="http://schemas.openxmlformats.org/officeDocument/2006/relationships/hyperlink" Target="http://rice.plantbiology.msu.edu/cgi-bin/ORF_infopage.cgi?orf=LOC_Os03g46950.1" TargetMode="External"/><Relationship Id="rId35" Type="http://schemas.openxmlformats.org/officeDocument/2006/relationships/hyperlink" Target="http://rice.plantbiology.msu.edu/cgi-bin/ORF_infopage.cgi?orf=LOC_Os03g47070.1" TargetMode="External"/><Relationship Id="rId43" Type="http://schemas.openxmlformats.org/officeDocument/2006/relationships/hyperlink" Target="http://rice.plantbiology.msu.edu/cgi-bin/ORF_infopage.cgi?orf=LOC_Os03g47246.1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ext Box 2"/>
          <p:cNvSpPr txBox="1">
            <a:spLocks noChangeArrowheads="1"/>
          </p:cNvSpPr>
          <p:nvPr/>
        </p:nvSpPr>
        <p:spPr bwMode="auto">
          <a:xfrm>
            <a:off x="-4763" y="0"/>
            <a:ext cx="9148763" cy="26193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Additional file 12:Table S2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Arial" pitchFamily="34" charset="0"/>
              </a:rPr>
              <a:t> List of candidate genes identified within the fine-mapped region (475 kb) along with their putative function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3120959"/>
              </p:ext>
            </p:extLst>
          </p:nvPr>
        </p:nvGraphicFramePr>
        <p:xfrm>
          <a:off x="1" y="304801"/>
          <a:ext cx="9144000" cy="6880860"/>
        </p:xfrm>
        <a:graphic>
          <a:graphicData uri="http://schemas.openxmlformats.org/drawingml/2006/table">
            <a:tbl>
              <a:tblPr/>
              <a:tblGrid>
                <a:gridCol w="345702"/>
                <a:gridCol w="949697"/>
                <a:gridCol w="3914619"/>
                <a:gridCol w="3933982"/>
              </a:tblGrid>
              <a:tr h="147084">
                <a:tc>
                  <a:txBody>
                    <a:bodyPr/>
                    <a:lstStyle/>
                    <a:p>
                      <a:pPr algn="ctr"/>
                      <a:r>
                        <a:rPr lang="fil-PH" sz="700" b="1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Sl</a:t>
                      </a:r>
                      <a:r>
                        <a:rPr lang="fil-PH" sz="700" b="1" dirty="0">
                          <a:solidFill>
                            <a:srgbClr val="000000"/>
                          </a:solidFill>
                          <a:latin typeface="Times New Roman"/>
                        </a:rPr>
                        <a:t>. no.</a:t>
                      </a:r>
                      <a:r>
                        <a:rPr lang="en-US" sz="700" b="1" dirty="0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</a:p>
                  </a:txBody>
                  <a:tcPr marL="26033" marR="26033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fil-PH" sz="7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Candidate gene</a:t>
                      </a:r>
                      <a:endParaRPr lang="en-US" sz="700" b="1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fil-PH" sz="7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ype of protein</a:t>
                      </a:r>
                      <a:endParaRPr lang="en-US" sz="700" b="1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fil-PH" sz="7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Function</a:t>
                      </a:r>
                      <a:endParaRPr lang="en-US" sz="700" b="1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"/>
                        </a:rPr>
                        <a:t>LOC_Os03g4644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BTBA4: Bric-a-Brac, Tramtrack, broad complex BTB domain with ankyrin repeat regio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esponse to biotic stress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"/>
                        </a:rPr>
                        <a:t>LOC_Os03g4645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etrotransposon protein, putative, Ty1-copia subclass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no gene ontology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4"/>
                        </a:rPr>
                        <a:t>LOC_Os03g46454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etal cation transporter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esponse to biotic stimulus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5"/>
                        </a:rPr>
                        <a:t>LOC_Os03g4646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biquitin carboxyl-terminal hydrolase, family 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embrane-associated salt-inducible protein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5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6"/>
                        </a:rPr>
                        <a:t>LOC_Os03g4647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etal cation transporter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etal cation transporter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6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7"/>
                        </a:rPr>
                        <a:t>LOC_Os03g4648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nBP1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nBP1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7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8"/>
                        </a:rPr>
                        <a:t>LOC_Os03g4649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0S ribosomal protein S2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0S ribosomal protein S2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8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9"/>
                        </a:rPr>
                        <a:t>LOC_Os03g4651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sFBX103: F-box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sFBX103: F-box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9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none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0"/>
                        </a:rPr>
                        <a:t>LOC_Os03g46500.1</a:t>
                      </a:r>
                      <a:endParaRPr lang="en-US" sz="700" u="none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sFBX102: F-box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sFBX103: F-box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0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1"/>
                        </a:rPr>
                        <a:t>LOC_Os03g4655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GH1A, putative, expressed (LEUCINE-RICH REPEAT-CONTAINING PROTEIN)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disease resistance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2"/>
                        </a:rPr>
                        <a:t>LOC_Os03g4656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PD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embrane-associated salt-inducible protein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2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3"/>
                        </a:rPr>
                        <a:t>LOC_Os03g4657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rotein-binding protein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rotein-binding protein, putative, expressed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3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4"/>
                        </a:rPr>
                        <a:t>LOC_Os03g4659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unclassified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utative mutator-like transposase n=1 Tax=</a:t>
                      </a:r>
                      <a:r>
                        <a:rPr lang="fil-PH" sz="700" i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ryza sativa</a:t>
                      </a: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Japon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4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5"/>
                        </a:rPr>
                        <a:t>LOC_Os03g4660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cidic leucine-rich nuclear phosphoprotein 32-related protein 2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cidic leucine-rich nuclear phosphoprotein 32-related protein 2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5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6"/>
                        </a:rPr>
                        <a:t>LOC_Os03g4661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DEAD-box ATP-dependent RNA helicase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utative uncharacterized protein n=1 Tax=</a:t>
                      </a:r>
                      <a:r>
                        <a:rPr lang="fil-PH" sz="700" i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ryza sativa</a:t>
                      </a: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indica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6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7"/>
                        </a:rPr>
                        <a:t>LOC_Os03g4664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deoxyuridine 5-triphosphate nucleotidohydrolase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deoxyuridine 5-triphosphate nucleotidohydrolase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7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8"/>
                        </a:rPr>
                        <a:t>LOC_Os03g4665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WD domain, G-beta repeat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 protein beta subunit n=1 Tax=</a:t>
                      </a:r>
                      <a:r>
                        <a:rPr lang="fil-PH" sz="700" i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ryza sativa</a:t>
                      </a: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indica Group Rep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8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19"/>
                        </a:rPr>
                        <a:t>LOC_Os03g4666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lucan endo-1,3-beta-glucosidase precursor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utative uncharacterized protein n=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9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0"/>
                        </a:rPr>
                        <a:t>LOC_Os03g46674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unclassified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0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1"/>
                        </a:rPr>
                        <a:t>LOC_Os03g4669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sFBX105: F-box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2"/>
                        </a:rPr>
                        <a:t>LOC_Os03g4672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OsFBX106: F-box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2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3"/>
                        </a:rPr>
                        <a:t>LOC_Os03g4674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BC transporter, ATP-binding protein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BC transporter, ATP-binding protein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4"/>
                        </a:rPr>
                        <a:t>LOC_Os03g4675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PI mannosyltransferase 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PI mannosyltransferase 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4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5"/>
                        </a:rPr>
                        <a:t>LOC_Os03g4679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helix-loop-helix DNA-binding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utative ammonium transporter n=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5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6"/>
                        </a:rPr>
                        <a:t>LOC_Os03g4680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etrotransposon protein, putative, Ty1-copia subclass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hypothetical polyprotein n=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6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7"/>
                        </a:rPr>
                        <a:t>LOC_Os03g4683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unclassified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7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8"/>
                        </a:rPr>
                        <a:t>LOC_Os03g46884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CACTA, En/Spm subclass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8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29"/>
                        </a:rPr>
                        <a:t>LOC_Os03g4691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yruvate kinase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9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0"/>
                        </a:rPr>
                        <a:t>LOC_Os03g4695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DNA-binding protein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0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1"/>
                        </a:rPr>
                        <a:t>LOC_Os03g46970.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etrotransposon protein, putative, unclassified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2"/>
                        </a:rPr>
                        <a:t>LOC_Os03g4700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chalcone synthase 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esponse to abiotic stimulus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2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3"/>
                        </a:rPr>
                        <a:t>LOC_Os03g47016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homeobox protein knotted-1-like 10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3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4"/>
                        </a:rPr>
                        <a:t>LOC_Os03g47022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homeobox protein rough sheath 1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4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5"/>
                        </a:rPr>
                        <a:t>LOC_Os03g4707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XW8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early-responsive to dehydration protein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5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6"/>
                        </a:rPr>
                        <a:t>LOC_Os03g4710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etrotransposon protein, putative, Ty3-gypsy subclass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6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7"/>
                        </a:rPr>
                        <a:t>LOC_Os03g4712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CBS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7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8"/>
                        </a:rPr>
                        <a:t>LOC_Os03g4713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unclassified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8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39"/>
                        </a:rPr>
                        <a:t>LOC_Os03g4714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rowth-regulating factor protein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unclassified 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9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40"/>
                        </a:rPr>
                        <a:t>LOC_Os03g47169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eptidase family C50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0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41"/>
                        </a:rPr>
                        <a:t>LOC_Os03g4720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bZIP transcription factor domain-containing protein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1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42"/>
                        </a:rPr>
                        <a:t>LOC_Os03g47230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phytosulfokines precursor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0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2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u="sng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  <a:hlinkClick r:id="rId43"/>
                        </a:rPr>
                        <a:t>LOC_Os03g47246.1</a:t>
                      </a:r>
                      <a:endParaRPr lang="en-US" sz="70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CR8, putative, express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fil-PH" sz="7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on protein, putative, </a:t>
                      </a:r>
                      <a:r>
                        <a:rPr lang="fil-PH" sz="7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unclassified</a:t>
                      </a:r>
                      <a:endParaRPr lang="en-US" sz="700" dirty="0">
                        <a:solidFill>
                          <a:srgbClr val="000000"/>
                        </a:solidFill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6033" marR="2603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495300" y="-587375"/>
            <a:ext cx="9147175" cy="26193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686</Words>
  <Application>Microsoft Office PowerPoint</Application>
  <PresentationFormat>On-screen Show (4:3)</PresentationFormat>
  <Paragraphs>17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DPrahalada</dc:creator>
  <cp:lastModifiedBy>Balindan, Danica Joy</cp:lastModifiedBy>
  <cp:revision>33</cp:revision>
  <dcterms:created xsi:type="dcterms:W3CDTF">2016-10-22T05:16:24Z</dcterms:created>
  <dcterms:modified xsi:type="dcterms:W3CDTF">2017-08-15T05:47:38Z</dcterms:modified>
</cp:coreProperties>
</file>